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12" autoAdjust="0"/>
    <p:restoredTop sz="94660"/>
  </p:normalViewPr>
  <p:slideViewPr>
    <p:cSldViewPr>
      <p:cViewPr varScale="1">
        <p:scale>
          <a:sx n="62" d="100"/>
          <a:sy n="62" d="100"/>
        </p:scale>
        <p:origin x="2448" y="5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260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431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7252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5442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110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2790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330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072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9306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8337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362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6A777-784A-4760-87B9-89A49298A463}" type="datetimeFigureOut">
              <a:rPr lang="de-DE" smtClean="0"/>
              <a:t>15.05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9BCF4-5653-4526-B2E0-F652BEDED9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feld 38"/>
          <p:cNvSpPr txBox="1"/>
          <p:nvPr/>
        </p:nvSpPr>
        <p:spPr>
          <a:xfrm>
            <a:off x="188640" y="179512"/>
            <a:ext cx="336913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Course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S100B in all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revious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anti-PD-1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onotherapy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573016" y="179512"/>
            <a:ext cx="288032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ourse of S100B in patients with anti-PD-1 monotherapy immediately before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pi-Nivo</a:t>
            </a:r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D2DBF36-3923-423A-80F1-33EE25B872F8}"/>
              </a:ext>
            </a:extLst>
          </p:cNvPr>
          <p:cNvSpPr txBox="1"/>
          <p:nvPr/>
        </p:nvSpPr>
        <p:spPr>
          <a:xfrm>
            <a:off x="522041" y="3779912"/>
            <a:ext cx="600743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Line plots depicting the course of serum S100B values before and after start of ipilimumab + nivolumab in patients with progressive disease (PD) as best overall response (red points and red lines) vs. stable disease, partial response or complete response (not PD; black points and black lines). (A) All patients previously treated with anti-PD-1 antibodies (can be years ago). (B) Only patients with anti-PD-1 treatment immediately before starting ipilimumab + nivolumab, i.e. direct switch from mono-anti-PD-1 to combined anti-CTLA-4 + anti-PD-1.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BAEE9992-9023-42B3-9778-04520DA0D0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30" r="23356" b="26700"/>
          <a:stretch/>
        </p:blipFill>
        <p:spPr>
          <a:xfrm>
            <a:off x="346140" y="539552"/>
            <a:ext cx="3060000" cy="257365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3111B8AD-F58D-4383-9836-168AF6DBE32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73" r="23554" b="26857"/>
          <a:stretch/>
        </p:blipFill>
        <p:spPr>
          <a:xfrm>
            <a:off x="3717032" y="532899"/>
            <a:ext cx="3060000" cy="2580304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DB02C5FC-C851-4A3D-BE0D-B490C493EA74}"/>
              </a:ext>
            </a:extLst>
          </p:cNvPr>
          <p:cNvSpPr txBox="1"/>
          <p:nvPr/>
        </p:nvSpPr>
        <p:spPr>
          <a:xfrm>
            <a:off x="669836" y="3127699"/>
            <a:ext cx="2736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93887C27-2C4F-428D-A9B3-A2334FA4EF0D}"/>
              </a:ext>
            </a:extLst>
          </p:cNvPr>
          <p:cNvSpPr txBox="1"/>
          <p:nvPr/>
        </p:nvSpPr>
        <p:spPr>
          <a:xfrm>
            <a:off x="4031352" y="3131840"/>
            <a:ext cx="2736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ivolumab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92E68414-5A2B-473E-9538-5BCF712F4851}"/>
              </a:ext>
            </a:extLst>
          </p:cNvPr>
          <p:cNvSpPr txBox="1"/>
          <p:nvPr/>
        </p:nvSpPr>
        <p:spPr>
          <a:xfrm>
            <a:off x="176863" y="539552"/>
            <a:ext cx="338554" cy="18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erum S100B [µg/l]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593B9316-5BD9-4D13-8B18-6D573B62A649}"/>
              </a:ext>
            </a:extLst>
          </p:cNvPr>
          <p:cNvSpPr txBox="1"/>
          <p:nvPr/>
        </p:nvSpPr>
        <p:spPr>
          <a:xfrm>
            <a:off x="3557776" y="539552"/>
            <a:ext cx="338554" cy="18002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erum S100B [µg/l]</a:t>
            </a:r>
          </a:p>
        </p:txBody>
      </p:sp>
    </p:spTree>
    <p:extLst>
      <p:ext uri="{BB962C8B-B14F-4D97-AF65-F5344CB8AC3E}">
        <p14:creationId xmlns:p14="http://schemas.microsoft.com/office/powerpoint/2010/main" val="271945092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Microsoft Office PowerPoint</Application>
  <PresentationFormat>Letter (8,5x11 Zoll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kolaus Wagner</dc:creator>
  <cp:lastModifiedBy>Nikolaus</cp:lastModifiedBy>
  <cp:revision>45</cp:revision>
  <dcterms:created xsi:type="dcterms:W3CDTF">2015-02-26T10:00:16Z</dcterms:created>
  <dcterms:modified xsi:type="dcterms:W3CDTF">2018-05-15T21:10:16Z</dcterms:modified>
</cp:coreProperties>
</file>